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99" d="100"/>
          <a:sy n="99" d="100"/>
        </p:scale>
        <p:origin x="7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1488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7934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3011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9263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3656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7183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4123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0436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8174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605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19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396EB-8EE3-422C-B7DE-A59761912223}" type="datetimeFigureOut">
              <a:rPr lang="ko-KR" altLang="en-US" smtClean="0"/>
              <a:t>2018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FCA02-2543-47EF-B4F0-01A8165BA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0524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62152" y="3239757"/>
            <a:ext cx="2456017" cy="2131141"/>
          </a:xfrm>
          <a:prstGeom prst="rect">
            <a:avLst/>
          </a:prstGeom>
          <a:noFill/>
        </p:spPr>
      </p:pic>
      <p:pic>
        <p:nvPicPr>
          <p:cNvPr id="3" name="그림 2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62150" y="923860"/>
            <a:ext cx="2379848" cy="1973345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3792356" y="265715"/>
            <a:ext cx="4947385" cy="526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ATTGCA</a:t>
            </a:r>
            <a:endParaRPr lang="en-US" altLang="ko-KR" sz="1200" b="1" dirty="0">
              <a:latin typeface="굴림체" panose="020B0609000101010101" pitchFamily="49" charset="-127"/>
              <a:ea typeface="굴림체" panose="020B0609000101010101" pitchFamily="49" charset="-127"/>
            </a:endParaRP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I  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A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GGTGGCTGGTATGCAACACCGCACTCTCTACCATATCAAGTAAAGTTATTAATTGAAAAA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G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G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W  Y  A  T  P  H  S  L  P  Y  Q  V  K  L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L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I  E  K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AGTGGGATACATGCTTCATGCGGTGGTGTTATAATTCAACTGAAGTCTGGCAACGGTACA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S  G  I  H  A  S  C  G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G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V  I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I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Q  L  K  S  G  N  G  T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GACGCAGTCCTCACATCAGCACGTTGCCTTTATCAAGAATCATTAAGAAAACCTGTGCCC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D  A  V  L  T  S  A  R  C  L  Y  Q  E  S  L  R  K  P  V  P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GTGGATAAAGTTGATGTTATTAGTGGAGCTCACGATCTTGAAAACAACTTTGAAGAAAGT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V  D  K  V  D  V  I  S  G  A  H  D  L  E  N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N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F  E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E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S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CAAAGGAAAATCCCCGTTAAAAATTTTGTACTCCATCCGGAGTATAAAGGAAATTCAATT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Q  R  K  I  P  V  K  N  F  V  L  H  P  E  Y  K  G  N  S  I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AACGATATAGCATTGTTAAAATTGAAGGAGAAAATACTATACACAGACAAAACTCGACCA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N  D  I  A  L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L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K  L  K  E  K  I  L  Y  T  D  K  T  R  P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GCATGTTTACCTGACAAAGATGCAGAGCCGAGTGCGGGCGAGCTGTGTTATGCATCTGGA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A  C  L  P  D  K  D  A  E  P  S  A  G  E  L  C  Y  A  S  G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TGGGGATCCCCTTTCTCTGGAGCCGAGGATAGCGCAGTTTTGAAAATGGCAGCGATACCC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W  G  S  P  F  S  G  A  E  D  S  A  V  L  K  M  A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A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I  P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GTTCAAACTAAAGAGAAATGTAACTTGGCTGGTGGAATAGCAACCAGATTTTGTGCTGGA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V  Q  T  K  E  K  C  N  L  A  G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G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I  A  T  R  F  C  A  G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GGAAGCTTTGGAGGACACGGAATTTGTGACGGTGATTCAGGAGGACCATTAACATGCGAA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G  S  F  G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G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H  G  I  C  D  G  D  S  G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G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P  L  T  C  E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AGAAATGGAAAATTGGTTGTATTTGGCATATCAAGTGGACATACAGGCCTCTGTGGTCAA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R  N  G  K  L  V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V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F  G  I  S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S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G  H  T  G  L  C  G  Q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TATGGCAAACCAGGAATTTTTACAAAAGTATCATCCTTTTTGGATTGGATTAAAAAAACT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Y  G  K  P  G  I  F  T  K  V  S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S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F  L  D  W  I  K  </a:t>
            </a:r>
            <a:r>
              <a:rPr lang="en-US" altLang="ko-KR" sz="1200" b="1" dirty="0" err="1">
                <a:latin typeface="굴림체" panose="020B0609000101010101" pitchFamily="49" charset="-127"/>
                <a:ea typeface="굴림체" panose="020B0609000101010101" pitchFamily="49" charset="-127"/>
              </a:rPr>
              <a:t>K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 T </a:t>
            </a: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GATACA</a:t>
            </a:r>
            <a:endParaRPr lang="en-US" altLang="ko-KR" sz="1200" b="1" dirty="0">
              <a:latin typeface="굴림체" panose="020B0609000101010101" pitchFamily="49" charset="-127"/>
              <a:ea typeface="굴림체" panose="020B0609000101010101" pitchFamily="49" charset="-127"/>
            </a:endParaRPr>
          </a:p>
          <a:p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 D  </a:t>
            </a:r>
            <a:r>
              <a:rPr lang="en-US" altLang="ko-KR" sz="1200" b="1" dirty="0">
                <a:latin typeface="굴림체" panose="020B0609000101010101" pitchFamily="49" charset="-127"/>
                <a:ea typeface="굴림체" panose="020B0609000101010101" pitchFamily="49" charset="-127"/>
              </a:rPr>
              <a:t>T</a:t>
            </a:r>
            <a:endParaRPr lang="ko-KR" altLang="en-US" sz="1200" b="1" dirty="0">
              <a:latin typeface="굴림체" panose="020B0609000101010101" pitchFamily="49" charset="-127"/>
              <a:ea typeface="굴림체" panose="020B0609000101010101" pitchFamily="49" charset="-127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40634" y="5574694"/>
            <a:ext cx="710344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S2 Figure</a:t>
            </a:r>
            <a:r>
              <a:rPr lang="en-US" altLang="ko-KR" sz="1200" b="1" dirty="0"/>
              <a:t>.</a:t>
            </a:r>
            <a:r>
              <a:rPr lang="en-US" altLang="ko-KR" sz="1200" b="1" dirty="0"/>
              <a:t> </a:t>
            </a:r>
            <a:r>
              <a:rPr lang="en-US" altLang="ko-KR" sz="1200" b="1" dirty="0"/>
              <a:t>Representation of the 3D structure of TS </a:t>
            </a:r>
            <a:r>
              <a:rPr lang="en-US" altLang="ko-KR" sz="1200" b="1" dirty="0"/>
              <a:t>15-1n </a:t>
            </a:r>
            <a:r>
              <a:rPr lang="en-US" altLang="ko-KR" sz="1200" b="1" dirty="0"/>
              <a:t>and prediction of active sites. </a:t>
            </a:r>
            <a:r>
              <a:rPr lang="en-US" altLang="ko-KR" sz="1200" dirty="0"/>
              <a:t>The modeled structure of TS </a:t>
            </a:r>
            <a:r>
              <a:rPr lang="en-US" altLang="ko-KR" sz="1200" dirty="0"/>
              <a:t>15-1n </a:t>
            </a:r>
            <a:r>
              <a:rPr lang="en-US" altLang="ko-KR" sz="1200" dirty="0"/>
              <a:t>is shown as a surface representation (A), and a Cα trace representation (B). In TS-15-1n, predictions of the active sites (G227, S252, and H254) and the substrate binding sites (R88, D142, and S233) are shown in blue and red letters, respectively. </a:t>
            </a:r>
            <a:r>
              <a:rPr lang="en-US" altLang="ko-KR" sz="1200" dirty="0"/>
              <a:t>The </a:t>
            </a:r>
            <a:r>
              <a:rPr lang="en-US" altLang="ko-KR" sz="1200" dirty="0"/>
              <a:t>relative distribution of the surface charge is shown with acidic regions in red, basic regions in blue and neutral regions in white. Amino acid sequence of the </a:t>
            </a:r>
            <a:r>
              <a:rPr lang="en-US" altLang="ko-KR" sz="1200" dirty="0"/>
              <a:t>N-terminal </a:t>
            </a:r>
            <a:r>
              <a:rPr lang="en-US" altLang="ko-KR" sz="1200" dirty="0"/>
              <a:t>domain of TS 15-1 (C). </a:t>
            </a:r>
            <a:endParaRPr lang="ko-KR" altLang="en-US" sz="1200" dirty="0"/>
          </a:p>
        </p:txBody>
      </p:sp>
      <p:sp>
        <p:nvSpPr>
          <p:cNvPr id="11" name="TextBox 10"/>
          <p:cNvSpPr txBox="1"/>
          <p:nvPr/>
        </p:nvSpPr>
        <p:spPr bwMode="auto">
          <a:xfrm>
            <a:off x="633273" y="3239755"/>
            <a:ext cx="413896" cy="52322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2800" b="1" kern="0" dirty="0">
                <a:solidFill>
                  <a:sysClr val="windowText" lastClr="000000"/>
                </a:solidFill>
                <a:ea typeface="굴림" charset="-127"/>
                <a:cs typeface="Arial" pitchFamily="34" charset="0"/>
              </a:rPr>
              <a:t>B</a:t>
            </a:r>
            <a:endParaRPr lang="ko-KR" altLang="en-US" sz="2800" b="1" kern="0" dirty="0">
              <a:solidFill>
                <a:sysClr val="windowText" lastClr="000000"/>
              </a:solidFill>
              <a:ea typeface="굴림" charset="-127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 bwMode="auto">
          <a:xfrm>
            <a:off x="592779" y="581306"/>
            <a:ext cx="437940" cy="52322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2800" b="1" kern="0" dirty="0">
                <a:solidFill>
                  <a:sysClr val="windowText" lastClr="000000"/>
                </a:solidFill>
                <a:ea typeface="굴림" charset="-127"/>
                <a:cs typeface="Arial" pitchFamily="34" charset="0"/>
              </a:rPr>
              <a:t>A</a:t>
            </a:r>
            <a:endParaRPr lang="ko-KR" altLang="en-US" sz="2800" b="1" kern="0" dirty="0">
              <a:solidFill>
                <a:sysClr val="windowText" lastClr="000000"/>
              </a:solidFill>
              <a:ea typeface="굴림" charset="-127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 bwMode="auto">
          <a:xfrm>
            <a:off x="3229464" y="58086"/>
            <a:ext cx="413896" cy="52322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2800" b="1" kern="0" dirty="0">
                <a:solidFill>
                  <a:sysClr val="windowText" lastClr="000000"/>
                </a:solidFill>
                <a:ea typeface="굴림" charset="-127"/>
                <a:cs typeface="Arial" pitchFamily="34" charset="0"/>
              </a:rPr>
              <a:t>C</a:t>
            </a:r>
            <a:endParaRPr lang="ko-KR" altLang="en-US" sz="2800" b="1" kern="0" dirty="0">
              <a:solidFill>
                <a:sysClr val="windowText" lastClr="000000"/>
              </a:solidFill>
              <a:ea typeface="굴림" charset="-127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1489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2</Words>
  <Application>Microsoft Office PowerPoint</Application>
  <PresentationFormat>화면 슬라이드 쇼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굴림</vt:lpstr>
      <vt:lpstr>굴림체</vt:lpstr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k Sun Yu</dc:creator>
  <cp:lastModifiedBy>Hak Sun Yu</cp:lastModifiedBy>
  <cp:revision>1</cp:revision>
  <dcterms:created xsi:type="dcterms:W3CDTF">2018-10-22T23:33:47Z</dcterms:created>
  <dcterms:modified xsi:type="dcterms:W3CDTF">2018-10-22T23:34:17Z</dcterms:modified>
</cp:coreProperties>
</file>